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65" r:id="rId2"/>
    <p:sldId id="261" r:id="rId3"/>
    <p:sldId id="262" r:id="rId4"/>
    <p:sldId id="264" r:id="rId5"/>
    <p:sldId id="266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88" userDrawn="1">
          <p15:clr>
            <a:srgbClr val="A4A3A4"/>
          </p15:clr>
        </p15:guide>
        <p15:guide id="2" pos="211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79"/>
    <p:restoredTop sz="95213"/>
  </p:normalViewPr>
  <p:slideViewPr>
    <p:cSldViewPr snapToGrid="0" snapToObjects="1" showGuides="1">
      <p:cViewPr>
        <p:scale>
          <a:sx n="110" d="100"/>
          <a:sy n="110" d="100"/>
        </p:scale>
        <p:origin x="632" y="-576"/>
      </p:cViewPr>
      <p:guideLst>
        <p:guide orient="horz" pos="3188"/>
        <p:guide pos="211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/Desktop/Project/PIN%20and%20PID%20in%20reprogramming/data%20analysis/20241009_&#33865;&#23376;&#29983;&#38263;&#26781;&#20214;&#36264;&#21218;&#22294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438393288755341"/>
          <c:y val="4.4299267714395615E-2"/>
          <c:w val="0.81673764691770934"/>
          <c:h val="0.78344063565168287"/>
        </c:manualLayout>
      </c:layout>
      <c:lineChart>
        <c:grouping val="standard"/>
        <c:varyColors val="0"/>
        <c:ser>
          <c:idx val="0"/>
          <c:order val="0"/>
          <c:tx>
            <c:strRef>
              <c:f>工作表1!$G$32</c:f>
              <c:strCache>
                <c:ptCount val="1"/>
                <c:pt idx="0">
                  <c:v>WT</c:v>
                </c:pt>
              </c:strCache>
            </c:strRef>
          </c:tx>
          <c:spPr>
            <a:ln w="31750" cap="rnd">
              <a:solidFill>
                <a:schemeClr val="tx1">
                  <a:lumMod val="50000"/>
                  <a:lumOff val="5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>
                  <a:lumMod val="50000"/>
                  <a:lumOff val="50000"/>
                </a:schemeClr>
              </a:solidFill>
              <a:ln w="12700">
                <a:solidFill>
                  <a:schemeClr val="tx1">
                    <a:lumMod val="50000"/>
                    <a:lumOff val="5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工作表1!$H$55:$L$5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6</c:v>
                  </c:pt>
                  <c:pt idx="2">
                    <c:v>13</c:v>
                  </c:pt>
                  <c:pt idx="3">
                    <c:v>15</c:v>
                  </c:pt>
                  <c:pt idx="4">
                    <c:v>1</c:v>
                  </c:pt>
                </c:numCache>
              </c:numRef>
            </c:plus>
            <c:minus>
              <c:numRef>
                <c:f>工作表1!$H$55:$L$55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16</c:v>
                  </c:pt>
                  <c:pt idx="2">
                    <c:v>13</c:v>
                  </c:pt>
                  <c:pt idx="3">
                    <c:v>15</c:v>
                  </c:pt>
                  <c:pt idx="4">
                    <c:v>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bg2">
                    <a:lumMod val="50000"/>
                  </a:schemeClr>
                </a:solidFill>
                <a:round/>
              </a:ln>
              <a:effectLst/>
            </c:spPr>
          </c:errBars>
          <c:cat>
            <c:numRef>
              <c:f>工作表1!$H$31:$L$31</c:f>
              <c:numCache>
                <c:formatCode>General</c:formatCode>
                <c:ptCount val="5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</c:numCache>
            </c:numRef>
          </c:cat>
          <c:val>
            <c:numRef>
              <c:f>工作表1!$H$51:$L$51</c:f>
              <c:numCache>
                <c:formatCode>General</c:formatCode>
                <c:ptCount val="5"/>
                <c:pt idx="0">
                  <c:v>0</c:v>
                </c:pt>
                <c:pt idx="1">
                  <c:v>15</c:v>
                </c:pt>
                <c:pt idx="2">
                  <c:v>76</c:v>
                </c:pt>
                <c:pt idx="3">
                  <c:v>89</c:v>
                </c:pt>
                <c:pt idx="4">
                  <c:v>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B24-9848-BDE4-68E890C2C37E}"/>
            </c:ext>
          </c:extLst>
        </c:ser>
        <c:ser>
          <c:idx val="3"/>
          <c:order val="1"/>
          <c:tx>
            <c:strRef>
              <c:f>工作表1!$G$35</c:f>
              <c:strCache>
                <c:ptCount val="1"/>
                <c:pt idx="0">
                  <c:v>PINADD</c:v>
                </c:pt>
              </c:strCache>
            </c:strRef>
          </c:tx>
          <c:spPr>
            <a:ln w="28575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75000"/>
                </a:schemeClr>
              </a:solidFill>
              <a:ln w="9525">
                <a:solidFill>
                  <a:schemeClr val="accent1">
                    <a:lumMod val="75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工作表1!$H$56:$L$5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</c:v>
                  </c:pt>
                  <c:pt idx="2">
                    <c:v>10</c:v>
                  </c:pt>
                  <c:pt idx="3">
                    <c:v>10</c:v>
                  </c:pt>
                  <c:pt idx="4">
                    <c:v>2</c:v>
                  </c:pt>
                </c:numCache>
              </c:numRef>
            </c:plus>
            <c:minus>
              <c:numRef>
                <c:f>工作表1!$H$56:$L$56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4</c:v>
                  </c:pt>
                  <c:pt idx="2">
                    <c:v>10</c:v>
                  </c:pt>
                  <c:pt idx="3">
                    <c:v>10</c:v>
                  </c:pt>
                  <c:pt idx="4">
                    <c:v>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accent1">
                    <a:lumMod val="40000"/>
                    <a:lumOff val="60000"/>
                  </a:schemeClr>
                </a:solidFill>
                <a:round/>
              </a:ln>
              <a:effectLst/>
            </c:spPr>
          </c:errBars>
          <c:cat>
            <c:numRef>
              <c:f>工作表1!$H$31:$L$31</c:f>
              <c:numCache>
                <c:formatCode>General</c:formatCode>
                <c:ptCount val="5"/>
                <c:pt idx="0">
                  <c:v>0</c:v>
                </c:pt>
                <c:pt idx="1">
                  <c:v>24</c:v>
                </c:pt>
                <c:pt idx="2">
                  <c:v>48</c:v>
                </c:pt>
                <c:pt idx="3">
                  <c:v>72</c:v>
                </c:pt>
                <c:pt idx="4">
                  <c:v>96</c:v>
                </c:pt>
              </c:numCache>
            </c:numRef>
          </c:cat>
          <c:val>
            <c:numRef>
              <c:f>工作表1!$H$52:$L$52</c:f>
              <c:numCache>
                <c:formatCode>General</c:formatCode>
                <c:ptCount val="5"/>
                <c:pt idx="0">
                  <c:v>0</c:v>
                </c:pt>
                <c:pt idx="1">
                  <c:v>5</c:v>
                </c:pt>
                <c:pt idx="2">
                  <c:v>67</c:v>
                </c:pt>
                <c:pt idx="3">
                  <c:v>89</c:v>
                </c:pt>
                <c:pt idx="4">
                  <c:v>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B24-9848-BDE4-68E890C2C3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3339456"/>
        <c:axId val="2092559712"/>
      </c:lineChart>
      <c:catAx>
        <c:axId val="1433394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Time (hrs)</a:t>
                </a:r>
                <a:endParaRPr lang="zh-TW"/>
              </a:p>
            </c:rich>
          </c:tx>
          <c:layout>
            <c:manualLayout>
              <c:xMode val="edge"/>
              <c:yMode val="edge"/>
              <c:x val="0.47223532548362168"/>
              <c:y val="0.910852559543194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TW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50000"/>
                <a:lumOff val="5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2092559712"/>
        <c:crosses val="autoZero"/>
        <c:auto val="1"/>
        <c:lblAlgn val="ctr"/>
        <c:lblOffset val="100"/>
        <c:noMultiLvlLbl val="0"/>
      </c:catAx>
      <c:valAx>
        <c:axId val="2092559712"/>
        <c:scaling>
          <c:orientation val="minMax"/>
          <c:max val="12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programming rate (%)</a:t>
                </a:r>
                <a:endParaRPr lang="zh-TW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8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TW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>
                <a:lumMod val="50000"/>
                <a:lumOff val="5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143339456"/>
        <c:crosses val="autoZero"/>
        <c:crossBetween val="midCat"/>
      </c:valAx>
      <c:spPr>
        <a:noFill/>
        <a:ln>
          <a:solidFill>
            <a:schemeClr val="tx1">
              <a:lumMod val="50000"/>
              <a:lumOff val="50000"/>
            </a:schemeClr>
          </a:solidFill>
        </a:ln>
        <a:effectLst/>
      </c:spPr>
    </c:plotArea>
    <c:legend>
      <c:legendPos val="b"/>
      <c:layout>
        <c:manualLayout>
          <c:xMode val="edge"/>
          <c:yMode val="edge"/>
          <c:x val="0.6469315985145363"/>
          <c:y val="0.56320861065972339"/>
          <c:w val="0.27547439585514338"/>
          <c:h val="0.173427077545493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zh-TW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1">
          <a:latin typeface="+mn-lt"/>
        </a:defRPr>
      </a:pPr>
      <a:endParaRPr lang="zh-TW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C06758-600B-1445-8161-52073A01C3ED}" type="datetimeFigureOut">
              <a:rPr kumimoji="1" lang="zh-TW" altLang="en-US" smtClean="0"/>
              <a:t>2024/12/11</a:t>
            </a:fld>
            <a:endParaRPr kumimoji="1"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zh-TW" altLang="en-US"/>
              <a:t>編輯母片文字樣式
第二層
第三層
第四層
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CDA556-B795-8D4B-A8A1-87E66C002AFF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0484646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CDA556-B795-8D4B-A8A1-87E66C002AFF}" type="slidenum">
              <a:rPr kumimoji="1" lang="zh-TW" altLang="en-US" smtClean="0"/>
              <a:t>1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69172717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DCDA556-B795-8D4B-A8A1-87E66C002AFF}" type="slidenum">
              <a:rPr kumimoji="1" lang="zh-TW" altLang="en-US" smtClean="0"/>
              <a:t>4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9411997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4D165-469A-5A4C-857D-AEA7FC3CD449}" type="datetimeFigureOut">
              <a:rPr kumimoji="1" lang="zh-TW" altLang="en-US" smtClean="0"/>
              <a:t>2024/12/11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33BD0-B241-BC4F-AA8F-178A7BDB217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6401663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4D165-469A-5A4C-857D-AEA7FC3CD449}" type="datetimeFigureOut">
              <a:rPr kumimoji="1" lang="zh-TW" altLang="en-US" smtClean="0"/>
              <a:t>2024/12/11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33BD0-B241-BC4F-AA8F-178A7BDB217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978362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4D165-469A-5A4C-857D-AEA7FC3CD449}" type="datetimeFigureOut">
              <a:rPr kumimoji="1" lang="zh-TW" altLang="en-US" smtClean="0"/>
              <a:t>2024/12/11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33BD0-B241-BC4F-AA8F-178A7BDB217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224244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4D165-469A-5A4C-857D-AEA7FC3CD449}" type="datetimeFigureOut">
              <a:rPr kumimoji="1" lang="zh-TW" altLang="en-US" smtClean="0"/>
              <a:t>2024/12/11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33BD0-B241-BC4F-AA8F-178A7BDB217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652524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4D165-469A-5A4C-857D-AEA7FC3CD449}" type="datetimeFigureOut">
              <a:rPr kumimoji="1" lang="zh-TW" altLang="en-US" smtClean="0"/>
              <a:t>2024/12/11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33BD0-B241-BC4F-AA8F-178A7BDB217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583819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4D165-469A-5A4C-857D-AEA7FC3CD449}" type="datetimeFigureOut">
              <a:rPr kumimoji="1" lang="zh-TW" altLang="en-US" smtClean="0"/>
              <a:t>2024/12/11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33BD0-B241-BC4F-AA8F-178A7BDB217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560010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4D165-469A-5A4C-857D-AEA7FC3CD449}" type="datetimeFigureOut">
              <a:rPr kumimoji="1" lang="zh-TW" altLang="en-US" smtClean="0"/>
              <a:t>2024/12/11</a:t>
            </a:fld>
            <a:endParaRPr kumimoji="1"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33BD0-B241-BC4F-AA8F-178A7BDB217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0916963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4D165-469A-5A4C-857D-AEA7FC3CD449}" type="datetimeFigureOut">
              <a:rPr kumimoji="1" lang="zh-TW" altLang="en-US" smtClean="0"/>
              <a:t>2024/12/11</a:t>
            </a:fld>
            <a:endParaRPr kumimoji="1"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33BD0-B241-BC4F-AA8F-178A7BDB217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023472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4D165-469A-5A4C-857D-AEA7FC3CD449}" type="datetimeFigureOut">
              <a:rPr kumimoji="1" lang="zh-TW" altLang="en-US" smtClean="0"/>
              <a:t>2024/12/11</a:t>
            </a:fld>
            <a:endParaRPr kumimoji="1"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33BD0-B241-BC4F-AA8F-178A7BDB217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7595454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4D165-469A-5A4C-857D-AEA7FC3CD449}" type="datetimeFigureOut">
              <a:rPr kumimoji="1" lang="zh-TW" altLang="en-US" smtClean="0"/>
              <a:t>2024/12/11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33BD0-B241-BC4F-AA8F-178A7BDB217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0718890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F4D165-469A-5A4C-857D-AEA7FC3CD449}" type="datetimeFigureOut">
              <a:rPr kumimoji="1" lang="zh-TW" altLang="en-US" smtClean="0"/>
              <a:t>2024/12/11</a:t>
            </a:fld>
            <a:endParaRPr kumimoji="1"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433BD0-B241-BC4F-AA8F-178A7BDB217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5731971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
第二層
第三層
第四層
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F4D165-469A-5A4C-857D-AEA7FC3CD449}" type="datetimeFigureOut">
              <a:rPr kumimoji="1" lang="zh-TW" altLang="en-US" smtClean="0"/>
              <a:t>2024/12/11</a:t>
            </a:fld>
            <a:endParaRPr kumimoji="1"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433BD0-B241-BC4F-AA8F-178A7BDB2173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407860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7" Type="http://schemas.openxmlformats.org/officeDocument/2006/relationships/image" Target="../media/image10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tif"/><Relationship Id="rId5" Type="http://schemas.openxmlformats.org/officeDocument/2006/relationships/image" Target="../media/image8.tif"/><Relationship Id="rId4" Type="http://schemas.openxmlformats.org/officeDocument/2006/relationships/image" Target="../media/image7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microsoft.com/office/2007/relationships/hdphoto" Target="../media/hdphoto4.wdp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95033CA8-2386-C541-AFC6-3C55FE2CD6B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70000" contrast="4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8680" y="2370440"/>
            <a:ext cx="3670546" cy="1223515"/>
          </a:xfrm>
          <a:prstGeom prst="rect">
            <a:avLst/>
          </a:prstGeom>
          <a:ln w="19050">
            <a:solidFill>
              <a:schemeClr val="bg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BB219ED-05ED-FF48-82E9-63A3FE8EAC7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7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8680" y="3610691"/>
            <a:ext cx="3670546" cy="1223515"/>
          </a:xfrm>
          <a:prstGeom prst="rect">
            <a:avLst/>
          </a:prstGeom>
          <a:ln w="15875">
            <a:solidFill>
              <a:schemeClr val="bg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062CC642-4965-B245-9B1A-BA6F31DE273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7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8680" y="4850941"/>
            <a:ext cx="3670546" cy="1223516"/>
          </a:xfrm>
          <a:prstGeom prst="rect">
            <a:avLst/>
          </a:prstGeom>
          <a:ln w="15875">
            <a:solidFill>
              <a:schemeClr val="bg1"/>
            </a:solidFill>
          </a:ln>
        </p:spPr>
      </p:pic>
      <p:cxnSp>
        <p:nvCxnSpPr>
          <p:cNvPr id="7" name="Straight Connector 7">
            <a:extLst>
              <a:ext uri="{FF2B5EF4-FFF2-40B4-BE49-F238E27FC236}">
                <a16:creationId xmlns:a16="http://schemas.microsoft.com/office/drawing/2014/main" id="{0CBDB15B-6901-7842-8D69-170C6393EF49}"/>
              </a:ext>
            </a:extLst>
          </p:cNvPr>
          <p:cNvCxnSpPr/>
          <p:nvPr/>
        </p:nvCxnSpPr>
        <p:spPr>
          <a:xfrm>
            <a:off x="2948144" y="2301269"/>
            <a:ext cx="0" cy="3815583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8">
            <a:extLst>
              <a:ext uri="{FF2B5EF4-FFF2-40B4-BE49-F238E27FC236}">
                <a16:creationId xmlns:a16="http://schemas.microsoft.com/office/drawing/2014/main" id="{0F7AE996-7538-4D4F-9F26-C877E2193375}"/>
              </a:ext>
            </a:extLst>
          </p:cNvPr>
          <p:cNvCxnSpPr/>
          <p:nvPr/>
        </p:nvCxnSpPr>
        <p:spPr>
          <a:xfrm>
            <a:off x="4166453" y="2310194"/>
            <a:ext cx="0" cy="3815583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9">
            <a:extLst>
              <a:ext uri="{FF2B5EF4-FFF2-40B4-BE49-F238E27FC236}">
                <a16:creationId xmlns:a16="http://schemas.microsoft.com/office/drawing/2014/main" id="{AF9AFF23-582E-3C45-84BA-7906C78F2436}"/>
              </a:ext>
            </a:extLst>
          </p:cNvPr>
          <p:cNvSpPr txBox="1"/>
          <p:nvPr/>
        </p:nvSpPr>
        <p:spPr>
          <a:xfrm>
            <a:off x="1326082" y="2879454"/>
            <a:ext cx="4732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ock</a:t>
            </a:r>
          </a:p>
        </p:txBody>
      </p:sp>
      <p:sp>
        <p:nvSpPr>
          <p:cNvPr id="10" name="TextBox 10">
            <a:extLst>
              <a:ext uri="{FF2B5EF4-FFF2-40B4-BE49-F238E27FC236}">
                <a16:creationId xmlns:a16="http://schemas.microsoft.com/office/drawing/2014/main" id="{FC158BE4-86C3-D249-B4DB-387139E5D47B}"/>
              </a:ext>
            </a:extLst>
          </p:cNvPr>
          <p:cNvSpPr txBox="1"/>
          <p:nvPr/>
        </p:nvSpPr>
        <p:spPr>
          <a:xfrm>
            <a:off x="1134332" y="4119706"/>
            <a:ext cx="663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 </a:t>
            </a:r>
            <a:r>
              <a:rPr lang="en-US" sz="1000" dirty="0" err="1"/>
              <a:t>uM</a:t>
            </a:r>
            <a:r>
              <a:rPr lang="en-US" sz="1000" dirty="0"/>
              <a:t> IAA</a:t>
            </a:r>
          </a:p>
        </p:txBody>
      </p:sp>
      <p:sp>
        <p:nvSpPr>
          <p:cNvPr id="11" name="TextBox 11">
            <a:extLst>
              <a:ext uri="{FF2B5EF4-FFF2-40B4-BE49-F238E27FC236}">
                <a16:creationId xmlns:a16="http://schemas.microsoft.com/office/drawing/2014/main" id="{6B93DA46-14A4-584A-8111-B0804FC9C1C5}"/>
              </a:ext>
            </a:extLst>
          </p:cNvPr>
          <p:cNvSpPr txBox="1"/>
          <p:nvPr/>
        </p:nvSpPr>
        <p:spPr>
          <a:xfrm>
            <a:off x="1069226" y="5359957"/>
            <a:ext cx="7296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 </a:t>
            </a:r>
            <a:r>
              <a:rPr lang="en-US" sz="1000" dirty="0" err="1"/>
              <a:t>uM</a:t>
            </a:r>
            <a:r>
              <a:rPr lang="en-US" sz="1000" dirty="0"/>
              <a:t> IAA</a:t>
            </a:r>
          </a:p>
        </p:txBody>
      </p:sp>
      <p:sp>
        <p:nvSpPr>
          <p:cNvPr id="12" name="TextBox 12">
            <a:extLst>
              <a:ext uri="{FF2B5EF4-FFF2-40B4-BE49-F238E27FC236}">
                <a16:creationId xmlns:a16="http://schemas.microsoft.com/office/drawing/2014/main" id="{77D7DA8C-98C9-494D-8E09-DF656902A159}"/>
              </a:ext>
            </a:extLst>
          </p:cNvPr>
          <p:cNvSpPr txBox="1"/>
          <p:nvPr/>
        </p:nvSpPr>
        <p:spPr>
          <a:xfrm>
            <a:off x="2075681" y="5863385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accent6">
                    <a:lumMod val="75000"/>
                  </a:schemeClr>
                </a:solidFill>
              </a:rPr>
              <a:t>Venus</a:t>
            </a:r>
          </a:p>
        </p:txBody>
      </p:sp>
      <p:sp>
        <p:nvSpPr>
          <p:cNvPr id="13" name="TextBox 13">
            <a:extLst>
              <a:ext uri="{FF2B5EF4-FFF2-40B4-BE49-F238E27FC236}">
                <a16:creationId xmlns:a16="http://schemas.microsoft.com/office/drawing/2014/main" id="{87E7E53C-4109-DA4A-9503-1B642A44ED46}"/>
              </a:ext>
            </a:extLst>
          </p:cNvPr>
          <p:cNvSpPr txBox="1"/>
          <p:nvPr/>
        </p:nvSpPr>
        <p:spPr>
          <a:xfrm>
            <a:off x="3154747" y="5863385"/>
            <a:ext cx="7344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solidFill>
                  <a:srgbClr val="C00000"/>
                </a:solidFill>
              </a:rPr>
              <a:t>tmTomato</a:t>
            </a:r>
            <a:endParaRPr lang="en-US" sz="1000" dirty="0">
              <a:solidFill>
                <a:srgbClr val="C00000"/>
              </a:solidFill>
            </a:endParaRPr>
          </a:p>
        </p:txBody>
      </p:sp>
      <p:sp>
        <p:nvSpPr>
          <p:cNvPr id="14" name="TextBox 14">
            <a:extLst>
              <a:ext uri="{FF2B5EF4-FFF2-40B4-BE49-F238E27FC236}">
                <a16:creationId xmlns:a16="http://schemas.microsoft.com/office/drawing/2014/main" id="{FA4A3CA7-3C99-4544-B033-B2C2DF9FB891}"/>
              </a:ext>
            </a:extLst>
          </p:cNvPr>
          <p:cNvSpPr txBox="1"/>
          <p:nvPr/>
        </p:nvSpPr>
        <p:spPr>
          <a:xfrm>
            <a:off x="4474177" y="5863385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Merged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3363656D-C8F1-B44A-853E-9A973BEF222C}"/>
              </a:ext>
            </a:extLst>
          </p:cNvPr>
          <p:cNvSpPr/>
          <p:nvPr/>
        </p:nvSpPr>
        <p:spPr>
          <a:xfrm>
            <a:off x="851988" y="1471871"/>
            <a:ext cx="540393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solidFill>
                  <a:prstClr val="black"/>
                </a:solidFill>
                <a:cs typeface="+mj-cs"/>
              </a:rPr>
              <a:t>Figure S1. R2D2 auxin reporter line is responsive to exogenous auxin supply in a dose-dependent manner.</a:t>
            </a:r>
            <a:endParaRPr lang="zh-TW" altLang="en-US" sz="1200" b="1" dirty="0">
              <a:solidFill>
                <a:prstClr val="black"/>
              </a:solidFill>
              <a:cs typeface="+mj-cs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E261675C-1D3A-DB47-8855-6E23121B9F15}"/>
              </a:ext>
            </a:extLst>
          </p:cNvPr>
          <p:cNvSpPr/>
          <p:nvPr/>
        </p:nvSpPr>
        <p:spPr>
          <a:xfrm>
            <a:off x="1697549" y="6186023"/>
            <a:ext cx="3670546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R2D2 auxin reporter line is responsive to exogenous auxin supply in a dose-dependent manner.</a:t>
            </a:r>
            <a:endParaRPr lang="zh-TW" altLang="zh-TW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esh protonema tissues of the R2D2 auxin reporter line were cultured in an imaging dish and treated with IAA in the indicated concentration for 5 hours before imaging. The imaging settings were fixed for all three conditions.</a:t>
            </a:r>
            <a:endParaRPr lang="zh-TW" altLang="zh-TW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76654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D7E6B34-0799-BD40-AA80-B4A8B82D24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7" y="1025549"/>
            <a:ext cx="5915025" cy="1914702"/>
          </a:xfr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 altLang="zh-TW" sz="1200" b="1" dirty="0">
                <a:latin typeface="+mn-lt"/>
              </a:rPr>
              <a:t>Figure S2. </a:t>
            </a:r>
            <a:r>
              <a:rPr lang="en-US" altLang="zh-TW" sz="1200" b="1" dirty="0" err="1">
                <a:latin typeface="+mn-lt"/>
              </a:rPr>
              <a:t>Phosphomutations</a:t>
            </a:r>
            <a:r>
              <a:rPr lang="en-US" altLang="zh-TW" sz="1200" b="1" dirty="0">
                <a:latin typeface="+mn-lt"/>
              </a:rPr>
              <a:t> on </a:t>
            </a:r>
            <a:r>
              <a:rPr lang="en-US" altLang="zh-TW" sz="1200" b="1" dirty="0" err="1">
                <a:latin typeface="+mn-lt"/>
              </a:rPr>
              <a:t>PpPINA</a:t>
            </a:r>
            <a:r>
              <a:rPr lang="en-US" altLang="zh-TW" sz="1200" b="1" dirty="0">
                <a:latin typeface="+mn-lt"/>
              </a:rPr>
              <a:t> and wildtype </a:t>
            </a:r>
            <a:r>
              <a:rPr lang="en-US" altLang="zh-TW" sz="1200" b="1" dirty="0" err="1">
                <a:latin typeface="+mn-lt"/>
              </a:rPr>
              <a:t>KfPIN</a:t>
            </a:r>
            <a:r>
              <a:rPr lang="en-US" altLang="zh-TW" sz="1200" b="1" dirty="0">
                <a:latin typeface="+mn-lt"/>
              </a:rPr>
              <a:t> are capable of exporting auxin when overexpressing in </a:t>
            </a:r>
            <a:r>
              <a:rPr lang="en-US" altLang="zh-TW" sz="1200" b="1" i="1" dirty="0">
                <a:latin typeface="+mn-lt"/>
              </a:rPr>
              <a:t>P. patens</a:t>
            </a:r>
            <a:r>
              <a:rPr lang="en-US" altLang="zh-TW" sz="1200" b="1" dirty="0">
                <a:latin typeface="+mn-lt"/>
              </a:rPr>
              <a:t>. </a:t>
            </a:r>
            <a:endParaRPr lang="zh-TW" altLang="en-US" sz="1200" b="1" dirty="0">
              <a:latin typeface="+mn-lt"/>
            </a:endParaRPr>
          </a:p>
        </p:txBody>
      </p:sp>
      <p:graphicFrame>
        <p:nvGraphicFramePr>
          <p:cNvPr id="4" name="物件 3">
            <a:extLst>
              <a:ext uri="{FF2B5EF4-FFF2-40B4-BE49-F238E27FC236}">
                <a16:creationId xmlns:a16="http://schemas.microsoft.com/office/drawing/2014/main" id="{A1592918-9C87-4447-834B-1196AF6FA851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262853" y="2903729"/>
          <a:ext cx="1911384" cy="27569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7" name="Prism 8" r:id="rId3" imgW="2730549" imgH="3938556" progId="Prism8.Document">
                  <p:embed/>
                </p:oleObj>
              </mc:Choice>
              <mc:Fallback>
                <p:oleObj name="Prism 8" r:id="rId3" imgW="2730549" imgH="3938556" progId="Prism8.Document">
                  <p:embed/>
                  <p:pic>
                    <p:nvPicPr>
                      <p:cNvPr id="4" name="物件 3">
                        <a:extLst>
                          <a:ext uri="{FF2B5EF4-FFF2-40B4-BE49-F238E27FC236}">
                            <a16:creationId xmlns:a16="http://schemas.microsoft.com/office/drawing/2014/main" id="{A1592918-9C87-4447-834B-1196AF6FA8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62853" y="2903729"/>
                        <a:ext cx="1911384" cy="27569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文字方塊 4">
            <a:extLst>
              <a:ext uri="{FF2B5EF4-FFF2-40B4-BE49-F238E27FC236}">
                <a16:creationId xmlns:a16="http://schemas.microsoft.com/office/drawing/2014/main" id="{42550008-EB78-0346-8F76-F086387AD3C7}"/>
              </a:ext>
            </a:extLst>
          </p:cNvPr>
          <p:cNvSpPr txBox="1"/>
          <p:nvPr/>
        </p:nvSpPr>
        <p:spPr>
          <a:xfrm>
            <a:off x="2995835" y="413560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TW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09D4A656-AACD-2D47-8457-F1722D5108DE}"/>
              </a:ext>
            </a:extLst>
          </p:cNvPr>
          <p:cNvSpPr txBox="1"/>
          <p:nvPr/>
        </p:nvSpPr>
        <p:spPr>
          <a:xfrm>
            <a:off x="3208713" y="3255492"/>
            <a:ext cx="2471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TW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DA80E386-B004-3A46-9BDA-8D666036EEFE}"/>
              </a:ext>
            </a:extLst>
          </p:cNvPr>
          <p:cNvSpPr txBox="1"/>
          <p:nvPr/>
        </p:nvSpPr>
        <p:spPr>
          <a:xfrm>
            <a:off x="3429000" y="3577993"/>
            <a:ext cx="2471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TW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189447A1-3107-3B48-9D23-0B3199964783}"/>
              </a:ext>
            </a:extLst>
          </p:cNvPr>
          <p:cNvSpPr txBox="1"/>
          <p:nvPr/>
        </p:nvSpPr>
        <p:spPr>
          <a:xfrm>
            <a:off x="3851542" y="3398965"/>
            <a:ext cx="2471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TW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E28951A5-3E6F-0046-8673-5DA50E6FF9D7}"/>
              </a:ext>
            </a:extLst>
          </p:cNvPr>
          <p:cNvSpPr txBox="1"/>
          <p:nvPr/>
        </p:nvSpPr>
        <p:spPr>
          <a:xfrm>
            <a:off x="3633854" y="2845167"/>
            <a:ext cx="24718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TW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086DFE7B-F3FA-F841-8018-D458FEC89597}"/>
              </a:ext>
            </a:extLst>
          </p:cNvPr>
          <p:cNvSpPr/>
          <p:nvPr/>
        </p:nvSpPr>
        <p:spPr>
          <a:xfrm>
            <a:off x="1479216" y="5855694"/>
            <a:ext cx="3706177" cy="13234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altLang="zh-TW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mutations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en-US" altLang="zh-TW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PINA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wildtype </a:t>
            </a:r>
            <a:r>
              <a:rPr lang="en-US" altLang="zh-TW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fPIN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re capable of exporting auxin when overexpressing in </a:t>
            </a:r>
            <a:r>
              <a:rPr lang="en-US" altLang="zh-TW" sz="10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 patens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TW" altLang="zh-TW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uxin export assay was performed with the indicated </a:t>
            </a:r>
            <a:r>
              <a:rPr lang="en-US" altLang="zh-TW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PINA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riants and </a:t>
            </a:r>
            <a:r>
              <a:rPr lang="en-US" altLang="zh-TW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fPIN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FP overexpression. The detailed method is described in Figure 3A with slight modifications. The overexpression was activated by supplying 1 </a:t>
            </a:r>
            <a:r>
              <a:rPr lang="en-US" altLang="zh-TW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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stradiol for 3 days before the addition of H3-IAA. One-way ANOVA was employed for statistical analysis.  </a:t>
            </a:r>
            <a:endParaRPr lang="zh-TW" altLang="zh-TW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72741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2D181C97-AB39-8A4A-8E79-73267F8B8F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48469" y="1384654"/>
            <a:ext cx="5915025" cy="1183578"/>
          </a:xfr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en-US" altLang="zh-TW" sz="1200" b="1" dirty="0">
                <a:latin typeface="+mn-lt"/>
              </a:rPr>
              <a:t>Figure S3. Overexpressed </a:t>
            </a:r>
            <a:r>
              <a:rPr lang="en-US" altLang="zh-TW" sz="1200" b="1" dirty="0" err="1">
                <a:latin typeface="+mn-lt"/>
              </a:rPr>
              <a:t>PpPINA</a:t>
            </a:r>
            <a:r>
              <a:rPr lang="en-US" altLang="zh-TW" sz="1200" b="1" dirty="0">
                <a:latin typeface="+mn-lt"/>
              </a:rPr>
              <a:t>-GFP</a:t>
            </a:r>
            <a:r>
              <a:rPr lang="en-US" altLang="zh-TW" sz="1200" b="1" baseline="30000" dirty="0">
                <a:latin typeface="+mn-lt"/>
              </a:rPr>
              <a:t>AA</a:t>
            </a:r>
            <a:r>
              <a:rPr lang="en-US" altLang="zh-TW" sz="1200" b="1" dirty="0">
                <a:latin typeface="+mn-lt"/>
              </a:rPr>
              <a:t> is polarized before visible cell outgrow. </a:t>
            </a:r>
            <a:endParaRPr lang="zh-TW" altLang="en-US" sz="1200" b="1" dirty="0">
              <a:latin typeface="+mn-lt"/>
            </a:endParaRPr>
          </a:p>
        </p:txBody>
      </p:sp>
      <p:pic>
        <p:nvPicPr>
          <p:cNvPr id="5" name="內容版面配置區 4">
            <a:extLst>
              <a:ext uri="{FF2B5EF4-FFF2-40B4-BE49-F238E27FC236}">
                <a16:creationId xmlns:a16="http://schemas.microsoft.com/office/drawing/2014/main" id="{6EE648E6-BAEE-0A46-998F-91A3C725EC3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905000" y="2740713"/>
            <a:ext cx="1440000" cy="948082"/>
          </a:xfrm>
        </p:spPr>
      </p:pic>
      <p:pic>
        <p:nvPicPr>
          <p:cNvPr id="7" name="圖片 6">
            <a:extLst>
              <a:ext uri="{FF2B5EF4-FFF2-40B4-BE49-F238E27FC236}">
                <a16:creationId xmlns:a16="http://schemas.microsoft.com/office/drawing/2014/main" id="{D675D347-836F-A042-A30E-D16AC3EBE00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5000" y="3776731"/>
            <a:ext cx="1440000" cy="948083"/>
          </a:xfrm>
          <a:prstGeom prst="rect">
            <a:avLst/>
          </a:prstGeom>
        </p:spPr>
      </p:pic>
      <p:pic>
        <p:nvPicPr>
          <p:cNvPr id="9" name="圖片 8">
            <a:extLst>
              <a:ext uri="{FF2B5EF4-FFF2-40B4-BE49-F238E27FC236}">
                <a16:creationId xmlns:a16="http://schemas.microsoft.com/office/drawing/2014/main" id="{E6A646EB-2BBB-EC43-9F80-05DEB8A0E77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05000" y="4812750"/>
            <a:ext cx="1440000" cy="948083"/>
          </a:xfrm>
          <a:prstGeom prst="rect">
            <a:avLst/>
          </a:prstGeom>
        </p:spPr>
      </p:pic>
      <p:pic>
        <p:nvPicPr>
          <p:cNvPr id="11" name="圖片 10">
            <a:extLst>
              <a:ext uri="{FF2B5EF4-FFF2-40B4-BE49-F238E27FC236}">
                <a16:creationId xmlns:a16="http://schemas.microsoft.com/office/drawing/2014/main" id="{AD9D9C02-ED11-0745-B618-969900C9B54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9000" y="2741106"/>
            <a:ext cx="1440000" cy="948083"/>
          </a:xfrm>
          <a:prstGeom prst="rect">
            <a:avLst/>
          </a:prstGeom>
        </p:spPr>
      </p:pic>
      <p:pic>
        <p:nvPicPr>
          <p:cNvPr id="13" name="圖片 12">
            <a:extLst>
              <a:ext uri="{FF2B5EF4-FFF2-40B4-BE49-F238E27FC236}">
                <a16:creationId xmlns:a16="http://schemas.microsoft.com/office/drawing/2014/main" id="{5932A732-625E-FD49-B7C6-E31BCA3C1BF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29000" y="3776928"/>
            <a:ext cx="1440000" cy="948083"/>
          </a:xfrm>
          <a:prstGeom prst="rect">
            <a:avLst/>
          </a:prstGeom>
        </p:spPr>
      </p:pic>
      <p:pic>
        <p:nvPicPr>
          <p:cNvPr id="15" name="圖片 14">
            <a:extLst>
              <a:ext uri="{FF2B5EF4-FFF2-40B4-BE49-F238E27FC236}">
                <a16:creationId xmlns:a16="http://schemas.microsoft.com/office/drawing/2014/main" id="{ADED21FF-6B60-9749-94F2-1C7EA8ABEBA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29000" y="4812749"/>
            <a:ext cx="1440000" cy="948083"/>
          </a:xfrm>
          <a:prstGeom prst="rect">
            <a:avLst/>
          </a:prstGeom>
        </p:spPr>
      </p:pic>
      <p:sp>
        <p:nvSpPr>
          <p:cNvPr id="16" name="文字方塊 15">
            <a:extLst>
              <a:ext uri="{FF2B5EF4-FFF2-40B4-BE49-F238E27FC236}">
                <a16:creationId xmlns:a16="http://schemas.microsoft.com/office/drawing/2014/main" id="{983500A0-EB90-4B4D-A670-0401DE90881B}"/>
              </a:ext>
            </a:extLst>
          </p:cNvPr>
          <p:cNvSpPr txBox="1"/>
          <p:nvPr/>
        </p:nvSpPr>
        <p:spPr>
          <a:xfrm>
            <a:off x="2882350" y="3459539"/>
            <a:ext cx="5020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0:00</a:t>
            </a:r>
            <a:endParaRPr kumimoji="1" lang="zh-TW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A0FF13CC-5359-4D4B-81E5-E197E9B0CC29}"/>
              </a:ext>
            </a:extLst>
          </p:cNvPr>
          <p:cNvSpPr txBox="1"/>
          <p:nvPr/>
        </p:nvSpPr>
        <p:spPr>
          <a:xfrm>
            <a:off x="2882351" y="4485127"/>
            <a:ext cx="5020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6:00</a:t>
            </a:r>
            <a:endParaRPr kumimoji="1" lang="zh-TW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33C63B80-A74A-F54B-9F6D-F9A4F846005B}"/>
              </a:ext>
            </a:extLst>
          </p:cNvPr>
          <p:cNvSpPr txBox="1"/>
          <p:nvPr/>
        </p:nvSpPr>
        <p:spPr>
          <a:xfrm>
            <a:off x="2882352" y="5527681"/>
            <a:ext cx="5020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8:00</a:t>
            </a:r>
            <a:endParaRPr kumimoji="1" lang="zh-TW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076F86D8-F68A-D241-AA68-8DB48FB6FA50}"/>
              </a:ext>
            </a:extLst>
          </p:cNvPr>
          <p:cNvSpPr txBox="1"/>
          <p:nvPr/>
        </p:nvSpPr>
        <p:spPr>
          <a:xfrm>
            <a:off x="4411527" y="3442574"/>
            <a:ext cx="5020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:00</a:t>
            </a:r>
            <a:endParaRPr kumimoji="1" lang="zh-TW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357ED6E8-C500-4348-8528-A856099F24C7}"/>
              </a:ext>
            </a:extLst>
          </p:cNvPr>
          <p:cNvSpPr txBox="1"/>
          <p:nvPr/>
        </p:nvSpPr>
        <p:spPr>
          <a:xfrm>
            <a:off x="4411527" y="4475700"/>
            <a:ext cx="5020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:20</a:t>
            </a:r>
            <a:endParaRPr kumimoji="1" lang="zh-TW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>
            <a:extLst>
              <a:ext uri="{FF2B5EF4-FFF2-40B4-BE49-F238E27FC236}">
                <a16:creationId xmlns:a16="http://schemas.microsoft.com/office/drawing/2014/main" id="{3DD9801D-5FF3-3D4C-A94D-D6FC72CF5E2E}"/>
              </a:ext>
            </a:extLst>
          </p:cNvPr>
          <p:cNvSpPr txBox="1"/>
          <p:nvPr/>
        </p:nvSpPr>
        <p:spPr>
          <a:xfrm>
            <a:off x="4411527" y="5527681"/>
            <a:ext cx="5020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:20</a:t>
            </a:r>
            <a:endParaRPr kumimoji="1" lang="zh-TW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7A425A62-06A6-6C4E-9DA8-BF3B627B0DDA}"/>
              </a:ext>
            </a:extLst>
          </p:cNvPr>
          <p:cNvSpPr txBox="1"/>
          <p:nvPr/>
        </p:nvSpPr>
        <p:spPr>
          <a:xfrm>
            <a:off x="2837761" y="3321782"/>
            <a:ext cx="54053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0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r:min</a:t>
            </a:r>
            <a:endParaRPr kumimoji="1" lang="zh-TW" altLang="en-US" sz="10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三角形 22">
            <a:extLst>
              <a:ext uri="{FF2B5EF4-FFF2-40B4-BE49-F238E27FC236}">
                <a16:creationId xmlns:a16="http://schemas.microsoft.com/office/drawing/2014/main" id="{D31B7695-7580-F444-9025-0978C0B7EE25}"/>
              </a:ext>
            </a:extLst>
          </p:cNvPr>
          <p:cNvSpPr/>
          <p:nvPr/>
        </p:nvSpPr>
        <p:spPr>
          <a:xfrm rot="13618355">
            <a:off x="3132111" y="3858683"/>
            <a:ext cx="105562" cy="147442"/>
          </a:xfrm>
          <a:prstGeom prst="triangl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4" name="三角形 23">
            <a:extLst>
              <a:ext uri="{FF2B5EF4-FFF2-40B4-BE49-F238E27FC236}">
                <a16:creationId xmlns:a16="http://schemas.microsoft.com/office/drawing/2014/main" id="{B0C9BCE2-5E06-094F-91FB-FBE695CDAA90}"/>
              </a:ext>
            </a:extLst>
          </p:cNvPr>
          <p:cNvSpPr/>
          <p:nvPr/>
        </p:nvSpPr>
        <p:spPr>
          <a:xfrm rot="13618355">
            <a:off x="3132114" y="4898341"/>
            <a:ext cx="105562" cy="147442"/>
          </a:xfrm>
          <a:prstGeom prst="triangl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5" name="三角形 24">
            <a:extLst>
              <a:ext uri="{FF2B5EF4-FFF2-40B4-BE49-F238E27FC236}">
                <a16:creationId xmlns:a16="http://schemas.microsoft.com/office/drawing/2014/main" id="{EA89B54D-9BB4-EC43-97F0-ED0C8F50C8B5}"/>
              </a:ext>
            </a:extLst>
          </p:cNvPr>
          <p:cNvSpPr/>
          <p:nvPr/>
        </p:nvSpPr>
        <p:spPr>
          <a:xfrm rot="13618355">
            <a:off x="2784981" y="4871483"/>
            <a:ext cx="105562" cy="147442"/>
          </a:xfrm>
          <a:prstGeom prst="triangl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6" name="三角形 25">
            <a:extLst>
              <a:ext uri="{FF2B5EF4-FFF2-40B4-BE49-F238E27FC236}">
                <a16:creationId xmlns:a16="http://schemas.microsoft.com/office/drawing/2014/main" id="{1E9A1090-9A97-0345-AE26-C03DD8A517D8}"/>
              </a:ext>
            </a:extLst>
          </p:cNvPr>
          <p:cNvSpPr/>
          <p:nvPr/>
        </p:nvSpPr>
        <p:spPr>
          <a:xfrm rot="13618355">
            <a:off x="4674143" y="2819435"/>
            <a:ext cx="105562" cy="147442"/>
          </a:xfrm>
          <a:prstGeom prst="triangl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7" name="三角形 26">
            <a:extLst>
              <a:ext uri="{FF2B5EF4-FFF2-40B4-BE49-F238E27FC236}">
                <a16:creationId xmlns:a16="http://schemas.microsoft.com/office/drawing/2014/main" id="{55A0F25B-6B86-EA4C-A0E1-B2D319C869BE}"/>
              </a:ext>
            </a:extLst>
          </p:cNvPr>
          <p:cNvSpPr/>
          <p:nvPr/>
        </p:nvSpPr>
        <p:spPr>
          <a:xfrm rot="13618355">
            <a:off x="4705564" y="3835710"/>
            <a:ext cx="105562" cy="147442"/>
          </a:xfrm>
          <a:prstGeom prst="triangl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8" name="三角形 27">
            <a:extLst>
              <a:ext uri="{FF2B5EF4-FFF2-40B4-BE49-F238E27FC236}">
                <a16:creationId xmlns:a16="http://schemas.microsoft.com/office/drawing/2014/main" id="{67C6821F-7294-A342-8600-C25DA12F1913}"/>
              </a:ext>
            </a:extLst>
          </p:cNvPr>
          <p:cNvSpPr/>
          <p:nvPr/>
        </p:nvSpPr>
        <p:spPr>
          <a:xfrm rot="13618355">
            <a:off x="4303927" y="3808852"/>
            <a:ext cx="105562" cy="147442"/>
          </a:xfrm>
          <a:prstGeom prst="triangl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29" name="三角形 28">
            <a:extLst>
              <a:ext uri="{FF2B5EF4-FFF2-40B4-BE49-F238E27FC236}">
                <a16:creationId xmlns:a16="http://schemas.microsoft.com/office/drawing/2014/main" id="{ED4579FA-3D6C-EE45-A01F-C586976D1807}"/>
              </a:ext>
            </a:extLst>
          </p:cNvPr>
          <p:cNvSpPr/>
          <p:nvPr/>
        </p:nvSpPr>
        <p:spPr>
          <a:xfrm rot="13618355">
            <a:off x="4691628" y="4851684"/>
            <a:ext cx="105562" cy="147442"/>
          </a:xfrm>
          <a:prstGeom prst="triangl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0" name="三角形 29">
            <a:extLst>
              <a:ext uri="{FF2B5EF4-FFF2-40B4-BE49-F238E27FC236}">
                <a16:creationId xmlns:a16="http://schemas.microsoft.com/office/drawing/2014/main" id="{379A739A-6C73-894C-AA6A-6FB4C2E14979}"/>
              </a:ext>
            </a:extLst>
          </p:cNvPr>
          <p:cNvSpPr/>
          <p:nvPr/>
        </p:nvSpPr>
        <p:spPr>
          <a:xfrm rot="13618355">
            <a:off x="4289991" y="4824826"/>
            <a:ext cx="105562" cy="147442"/>
          </a:xfrm>
          <a:prstGeom prst="triangl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TW" altLang="en-US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5020D552-DDE6-244C-8A9D-97FDB884A820}"/>
              </a:ext>
            </a:extLst>
          </p:cNvPr>
          <p:cNvSpPr/>
          <p:nvPr/>
        </p:nvSpPr>
        <p:spPr>
          <a:xfrm>
            <a:off x="1714500" y="5900367"/>
            <a:ext cx="3429000" cy="1911292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Overexpressed </a:t>
            </a:r>
            <a:r>
              <a:rPr lang="en-US" altLang="zh-TW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PINA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FP</a:t>
            </a:r>
            <a:r>
              <a:rPr lang="en-US" altLang="zh-TW" sz="1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polarized before visible cells outgrow.</a:t>
            </a:r>
            <a:endParaRPr lang="zh-TW" altLang="zh-TW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TW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PINA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FP</a:t>
            </a:r>
            <a:r>
              <a:rPr lang="en-US" altLang="zh-TW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was induced by 1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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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stradiol upon wounding. The time-lapse imaging was started 30 hours (defined as time zero) after cutting until the visible cell outgrow. The white arrowheads indicate the localization of the </a:t>
            </a:r>
            <a:r>
              <a:rPr lang="en-US" altLang="zh-TW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PINA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FP</a:t>
            </a:r>
            <a:r>
              <a:rPr lang="en-US" altLang="zh-TW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A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ignal at the polar site of future outgrowing sites. </a:t>
            </a:r>
            <a:endParaRPr lang="zh-TW" altLang="zh-TW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45832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圖表 4">
            <a:extLst>
              <a:ext uri="{FF2B5EF4-FFF2-40B4-BE49-F238E27FC236}">
                <a16:creationId xmlns:a16="http://schemas.microsoft.com/office/drawing/2014/main" id="{77C07A38-9CC3-3F4C-B023-61112948380C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838633" y="3559278"/>
          <a:ext cx="2924878" cy="26951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矩形 5">
            <a:extLst>
              <a:ext uri="{FF2B5EF4-FFF2-40B4-BE49-F238E27FC236}">
                <a16:creationId xmlns:a16="http://schemas.microsoft.com/office/drawing/2014/main" id="{B749553A-01CC-614A-B64B-C2B1E7E693E9}"/>
              </a:ext>
            </a:extLst>
          </p:cNvPr>
          <p:cNvSpPr/>
          <p:nvPr/>
        </p:nvSpPr>
        <p:spPr>
          <a:xfrm>
            <a:off x="655598" y="1302134"/>
            <a:ext cx="540393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solidFill>
                  <a:prstClr val="black"/>
                </a:solidFill>
                <a:cs typeface="+mj-cs"/>
              </a:rPr>
              <a:t>Figure S4. Overexpression of </a:t>
            </a:r>
            <a:r>
              <a:rPr lang="en" altLang="zh-TW" sz="1200" b="1" dirty="0">
                <a:solidFill>
                  <a:prstClr val="black"/>
                </a:solidFill>
                <a:cs typeface="+mj-cs"/>
              </a:rPr>
              <a:t>phosphorylation mimic </a:t>
            </a:r>
            <a:r>
              <a:rPr lang="en" altLang="zh-TW" sz="1200" b="1" dirty="0" err="1">
                <a:solidFill>
                  <a:prstClr val="black"/>
                </a:solidFill>
                <a:cs typeface="+mj-cs"/>
              </a:rPr>
              <a:t>PpPINA</a:t>
            </a:r>
            <a:r>
              <a:rPr lang="en" altLang="zh-TW" sz="1200" b="1" dirty="0">
                <a:solidFill>
                  <a:prstClr val="black"/>
                </a:solidFill>
                <a:cs typeface="+mj-cs"/>
              </a:rPr>
              <a:t> did not affect leaf cell reprogramming.</a:t>
            </a:r>
            <a:r>
              <a:rPr lang="en-US" altLang="zh-TW" sz="1200" b="1" dirty="0">
                <a:solidFill>
                  <a:prstClr val="black"/>
                </a:solidFill>
                <a:cs typeface="+mj-cs"/>
              </a:rPr>
              <a:t> </a:t>
            </a:r>
            <a:endParaRPr lang="zh-TW" altLang="en-US" sz="1200" b="1" dirty="0">
              <a:solidFill>
                <a:prstClr val="black"/>
              </a:solidFill>
              <a:cs typeface="+mj-cs"/>
            </a:endParaRPr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8891A0CC-BD65-6F4D-9657-68096EB88FBA}"/>
              </a:ext>
            </a:extLst>
          </p:cNvPr>
          <p:cNvSpPr txBox="1"/>
          <p:nvPr/>
        </p:nvSpPr>
        <p:spPr>
          <a:xfrm>
            <a:off x="4129549" y="5309419"/>
            <a:ext cx="48178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zh-TW" sz="800" b="1" dirty="0"/>
              <a:t>PINA</a:t>
            </a:r>
            <a:r>
              <a:rPr kumimoji="1" lang="en-US" altLang="zh-TW" sz="800" b="1" baseline="30000" dirty="0"/>
              <a:t>DD</a:t>
            </a:r>
            <a:endParaRPr kumimoji="1" lang="zh-TW" altLang="en-US" sz="800" b="1" baseline="30000" dirty="0"/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6E73695C-4AD0-F946-BFAC-B0EC9C794D80}"/>
              </a:ext>
            </a:extLst>
          </p:cNvPr>
          <p:cNvSpPr txBox="1"/>
          <p:nvPr/>
        </p:nvSpPr>
        <p:spPr>
          <a:xfrm>
            <a:off x="4129549" y="5093975"/>
            <a:ext cx="48178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kumimoji="1" lang="en-US" altLang="zh-TW" sz="800" b="1" dirty="0"/>
              <a:t>WT</a:t>
            </a:r>
            <a:endParaRPr kumimoji="1" lang="zh-TW" altLang="en-US" sz="800" b="1" baseline="30000" dirty="0"/>
          </a:p>
        </p:txBody>
      </p:sp>
      <p:pic>
        <p:nvPicPr>
          <p:cNvPr id="10" name="Picture 19">
            <a:extLst>
              <a:ext uri="{FF2B5EF4-FFF2-40B4-BE49-F238E27FC236}">
                <a16:creationId xmlns:a16="http://schemas.microsoft.com/office/drawing/2014/main" id="{C7B18FA2-B41B-B441-A4B9-113C568DA20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00104" y="2603399"/>
            <a:ext cx="2457792" cy="921672"/>
          </a:xfrm>
          <a:prstGeom prst="rect">
            <a:avLst/>
          </a:prstGeom>
          <a:ln>
            <a:solidFill>
              <a:schemeClr val="bg1"/>
            </a:solidFill>
          </a:ln>
        </p:spPr>
      </p:pic>
      <p:sp>
        <p:nvSpPr>
          <p:cNvPr id="19" name="TextBox 28">
            <a:extLst>
              <a:ext uri="{FF2B5EF4-FFF2-40B4-BE49-F238E27FC236}">
                <a16:creationId xmlns:a16="http://schemas.microsoft.com/office/drawing/2014/main" id="{1B4CF0A5-1533-B24D-9AFB-3E1E8C2EBCB1}"/>
              </a:ext>
            </a:extLst>
          </p:cNvPr>
          <p:cNvSpPr txBox="1"/>
          <p:nvPr/>
        </p:nvSpPr>
        <p:spPr>
          <a:xfrm>
            <a:off x="2115784" y="2421297"/>
            <a:ext cx="8963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PpPIN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GFP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DD</a:t>
            </a: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7396F09B-2673-9244-B240-07E7B6B1AAD1}"/>
              </a:ext>
            </a:extLst>
          </p:cNvPr>
          <p:cNvSpPr/>
          <p:nvPr/>
        </p:nvSpPr>
        <p:spPr>
          <a:xfrm>
            <a:off x="1714500" y="6469916"/>
            <a:ext cx="3429000" cy="168046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Overexpression of phosphorylation mimicking </a:t>
            </a:r>
            <a:r>
              <a:rPr lang="en-US" altLang="zh-TW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PINA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d not affect leaf cell reprogramming. </a:t>
            </a:r>
            <a:endParaRPr lang="zh-TW" altLang="zh-TW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TW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PINA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FP</a:t>
            </a:r>
            <a:r>
              <a:rPr lang="en-US" altLang="zh-TW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D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 was induced by 1 </a:t>
            </a:r>
            <a:r>
              <a:rPr lang="en-US" altLang="zh-TW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itchFamily="2" charset="2"/>
              </a:rPr>
              <a:t>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estradiol for 3 days. The signal of </a:t>
            </a:r>
            <a:r>
              <a:rPr lang="en-US" altLang="zh-TW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PINA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FP</a:t>
            </a:r>
            <a:r>
              <a:rPr lang="en-US" altLang="zh-TW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D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evenly distributed on the plasma membrane with very low intensity. The leaf cell reprogramming rate was unaffected and showed similar efficiency as WT.</a:t>
            </a:r>
            <a:endParaRPr lang="zh-TW" altLang="zh-TW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55825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29FB06C-250D-614C-9548-321605BF0E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en-US" altLang="zh-TW" dirty="0"/>
              <a:t> </a:t>
            </a:r>
            <a:endParaRPr kumimoji="1" lang="zh-TW" altLang="en-US" dirty="0"/>
          </a:p>
        </p:txBody>
      </p:sp>
      <p:sp>
        <p:nvSpPr>
          <p:cNvPr id="4" name="手繪多邊形 3">
            <a:extLst>
              <a:ext uri="{FF2B5EF4-FFF2-40B4-BE49-F238E27FC236}">
                <a16:creationId xmlns:a16="http://schemas.microsoft.com/office/drawing/2014/main" id="{79356ED3-7855-4546-BE5C-508BFAE29F67}"/>
              </a:ext>
            </a:extLst>
          </p:cNvPr>
          <p:cNvSpPr/>
          <p:nvPr/>
        </p:nvSpPr>
        <p:spPr>
          <a:xfrm>
            <a:off x="2099443" y="2841345"/>
            <a:ext cx="2540580" cy="636839"/>
          </a:xfrm>
          <a:custGeom>
            <a:avLst/>
            <a:gdLst>
              <a:gd name="connsiteX0" fmla="*/ 0 w 3854823"/>
              <a:gd name="connsiteY0" fmla="*/ 53789 h 1111735"/>
              <a:gd name="connsiteX1" fmla="*/ 1918447 w 3854823"/>
              <a:gd name="connsiteY1" fmla="*/ 1111624 h 1111735"/>
              <a:gd name="connsiteX2" fmla="*/ 3854823 w 3854823"/>
              <a:gd name="connsiteY2" fmla="*/ 0 h 1111735"/>
              <a:gd name="connsiteX0" fmla="*/ 0 w 3797699"/>
              <a:gd name="connsiteY0" fmla="*/ 0 h 1060896"/>
              <a:gd name="connsiteX1" fmla="*/ 1918447 w 3797699"/>
              <a:gd name="connsiteY1" fmla="*/ 1057835 h 1060896"/>
              <a:gd name="connsiteX2" fmla="*/ 3797699 w 3797699"/>
              <a:gd name="connsiteY2" fmla="*/ 227632 h 1060896"/>
              <a:gd name="connsiteX0" fmla="*/ 0 w 3809124"/>
              <a:gd name="connsiteY0" fmla="*/ 0 h 1162108"/>
              <a:gd name="connsiteX1" fmla="*/ 1929872 w 3809124"/>
              <a:gd name="connsiteY1" fmla="*/ 1156332 h 1162108"/>
              <a:gd name="connsiteX2" fmla="*/ 3809124 w 3809124"/>
              <a:gd name="connsiteY2" fmla="*/ 326129 h 1162108"/>
              <a:gd name="connsiteX0" fmla="*/ 0 w 3809124"/>
              <a:gd name="connsiteY0" fmla="*/ 0 h 1162108"/>
              <a:gd name="connsiteX1" fmla="*/ 1735651 w 3809124"/>
              <a:gd name="connsiteY1" fmla="*/ 1156332 h 1162108"/>
              <a:gd name="connsiteX2" fmla="*/ 3809124 w 3809124"/>
              <a:gd name="connsiteY2" fmla="*/ 326129 h 1162108"/>
              <a:gd name="connsiteX0" fmla="*/ 0 w 3809124"/>
              <a:gd name="connsiteY0" fmla="*/ 0 h 1175982"/>
              <a:gd name="connsiteX1" fmla="*/ 1769926 w 3809124"/>
              <a:gd name="connsiteY1" fmla="*/ 1170403 h 1175982"/>
              <a:gd name="connsiteX2" fmla="*/ 3809124 w 3809124"/>
              <a:gd name="connsiteY2" fmla="*/ 326129 h 11759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809124" h="1175982">
                <a:moveTo>
                  <a:pt x="0" y="0"/>
                </a:moveTo>
                <a:cubicBezTo>
                  <a:pt x="637988" y="533400"/>
                  <a:pt x="1135072" y="1116048"/>
                  <a:pt x="1769926" y="1170403"/>
                </a:cubicBezTo>
                <a:cubicBezTo>
                  <a:pt x="2404780" y="1224758"/>
                  <a:pt x="3162171" y="877458"/>
                  <a:pt x="3809124" y="326129"/>
                </a:cubicBezTo>
              </a:path>
            </a:pathLst>
          </a:custGeom>
          <a:noFill/>
          <a:ln w="28575"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 sz="800" dirty="0"/>
          </a:p>
        </p:txBody>
      </p:sp>
      <p:sp>
        <p:nvSpPr>
          <p:cNvPr id="6" name="手繪多邊形 5">
            <a:extLst>
              <a:ext uri="{FF2B5EF4-FFF2-40B4-BE49-F238E27FC236}">
                <a16:creationId xmlns:a16="http://schemas.microsoft.com/office/drawing/2014/main" id="{068C0A3A-9C50-F749-B937-CDCE7FF82089}"/>
              </a:ext>
            </a:extLst>
          </p:cNvPr>
          <p:cNvSpPr/>
          <p:nvPr/>
        </p:nvSpPr>
        <p:spPr>
          <a:xfrm>
            <a:off x="2110864" y="2976455"/>
            <a:ext cx="2517738" cy="562006"/>
          </a:xfrm>
          <a:custGeom>
            <a:avLst/>
            <a:gdLst>
              <a:gd name="connsiteX0" fmla="*/ 0 w 4285130"/>
              <a:gd name="connsiteY0" fmla="*/ 1039906 h 1182790"/>
              <a:gd name="connsiteX1" fmla="*/ 3209365 w 4285130"/>
              <a:gd name="connsiteY1" fmla="*/ 1093694 h 1182790"/>
              <a:gd name="connsiteX2" fmla="*/ 4285130 w 4285130"/>
              <a:gd name="connsiteY2" fmla="*/ 0 h 1182790"/>
              <a:gd name="connsiteX0" fmla="*/ 0 w 4285130"/>
              <a:gd name="connsiteY0" fmla="*/ 1039906 h 1136349"/>
              <a:gd name="connsiteX1" fmla="*/ 3476065 w 4285130"/>
              <a:gd name="connsiteY1" fmla="*/ 1017494 h 1136349"/>
              <a:gd name="connsiteX2" fmla="*/ 4285130 w 4285130"/>
              <a:gd name="connsiteY2" fmla="*/ 0 h 1136349"/>
              <a:gd name="connsiteX0" fmla="*/ 0 w 4285130"/>
              <a:gd name="connsiteY0" fmla="*/ 1039906 h 1165894"/>
              <a:gd name="connsiteX1" fmla="*/ 3552265 w 4285130"/>
              <a:gd name="connsiteY1" fmla="*/ 1068294 h 1165894"/>
              <a:gd name="connsiteX2" fmla="*/ 4285130 w 4285130"/>
              <a:gd name="connsiteY2" fmla="*/ 0 h 1165894"/>
              <a:gd name="connsiteX0" fmla="*/ 0 w 4297830"/>
              <a:gd name="connsiteY0" fmla="*/ 900206 h 1016231"/>
              <a:gd name="connsiteX1" fmla="*/ 3552265 w 4297830"/>
              <a:gd name="connsiteY1" fmla="*/ 928594 h 1016231"/>
              <a:gd name="connsiteX2" fmla="*/ 4297830 w 4297830"/>
              <a:gd name="connsiteY2" fmla="*/ 0 h 1016231"/>
              <a:gd name="connsiteX0" fmla="*/ 0 w 4297830"/>
              <a:gd name="connsiteY0" fmla="*/ 900206 h 1008497"/>
              <a:gd name="connsiteX1" fmla="*/ 3590365 w 4297830"/>
              <a:gd name="connsiteY1" fmla="*/ 915894 h 1008497"/>
              <a:gd name="connsiteX2" fmla="*/ 4297830 w 4297830"/>
              <a:gd name="connsiteY2" fmla="*/ 0 h 1008497"/>
              <a:gd name="connsiteX0" fmla="*/ 0 w 4348630"/>
              <a:gd name="connsiteY0" fmla="*/ 836706 h 940622"/>
              <a:gd name="connsiteX1" fmla="*/ 3590365 w 4348630"/>
              <a:gd name="connsiteY1" fmla="*/ 852394 h 940622"/>
              <a:gd name="connsiteX2" fmla="*/ 4348630 w 4348630"/>
              <a:gd name="connsiteY2" fmla="*/ 0 h 940622"/>
              <a:gd name="connsiteX0" fmla="*/ 0 w 4348630"/>
              <a:gd name="connsiteY0" fmla="*/ 836706 h 992022"/>
              <a:gd name="connsiteX1" fmla="*/ 3539565 w 4348630"/>
              <a:gd name="connsiteY1" fmla="*/ 928594 h 992022"/>
              <a:gd name="connsiteX2" fmla="*/ 4348630 w 4348630"/>
              <a:gd name="connsiteY2" fmla="*/ 0 h 992022"/>
              <a:gd name="connsiteX0" fmla="*/ 0 w 4348630"/>
              <a:gd name="connsiteY0" fmla="*/ 836706 h 1042806"/>
              <a:gd name="connsiteX1" fmla="*/ 3539565 w 4348630"/>
              <a:gd name="connsiteY1" fmla="*/ 928594 h 1042806"/>
              <a:gd name="connsiteX2" fmla="*/ 4348630 w 4348630"/>
              <a:gd name="connsiteY2" fmla="*/ 0 h 1042806"/>
              <a:gd name="connsiteX0" fmla="*/ 0 w 4348630"/>
              <a:gd name="connsiteY0" fmla="*/ 836706 h 1099244"/>
              <a:gd name="connsiteX1" fmla="*/ 3539565 w 4348630"/>
              <a:gd name="connsiteY1" fmla="*/ 928594 h 1099244"/>
              <a:gd name="connsiteX2" fmla="*/ 4348630 w 4348630"/>
              <a:gd name="connsiteY2" fmla="*/ 0 h 1099244"/>
              <a:gd name="connsiteX0" fmla="*/ 0 w 4285130"/>
              <a:gd name="connsiteY0" fmla="*/ 912906 h 1022076"/>
              <a:gd name="connsiteX1" fmla="*/ 3476065 w 4285130"/>
              <a:gd name="connsiteY1" fmla="*/ 928594 h 1022076"/>
              <a:gd name="connsiteX2" fmla="*/ 4285130 w 4285130"/>
              <a:gd name="connsiteY2" fmla="*/ 0 h 1022076"/>
              <a:gd name="connsiteX0" fmla="*/ 0 w 4183530"/>
              <a:gd name="connsiteY0" fmla="*/ 709706 h 805013"/>
              <a:gd name="connsiteX1" fmla="*/ 3476065 w 4183530"/>
              <a:gd name="connsiteY1" fmla="*/ 725394 h 805013"/>
              <a:gd name="connsiteX2" fmla="*/ 4183530 w 4183530"/>
              <a:gd name="connsiteY2" fmla="*/ 0 h 805013"/>
              <a:gd name="connsiteX0" fmla="*/ 0 w 4183530"/>
              <a:gd name="connsiteY0" fmla="*/ 824006 h 927052"/>
              <a:gd name="connsiteX1" fmla="*/ 3476065 w 4183530"/>
              <a:gd name="connsiteY1" fmla="*/ 839694 h 927052"/>
              <a:gd name="connsiteX2" fmla="*/ 4183530 w 4183530"/>
              <a:gd name="connsiteY2" fmla="*/ 0 h 927052"/>
              <a:gd name="connsiteX0" fmla="*/ 0 w 4183530"/>
              <a:gd name="connsiteY0" fmla="*/ 824006 h 934645"/>
              <a:gd name="connsiteX1" fmla="*/ 3476065 w 4183530"/>
              <a:gd name="connsiteY1" fmla="*/ 852394 h 934645"/>
              <a:gd name="connsiteX2" fmla="*/ 4183530 w 4183530"/>
              <a:gd name="connsiteY2" fmla="*/ 0 h 934645"/>
              <a:gd name="connsiteX0" fmla="*/ 0 w 4170830"/>
              <a:gd name="connsiteY0" fmla="*/ 582706 h 676625"/>
              <a:gd name="connsiteX1" fmla="*/ 3476065 w 4170830"/>
              <a:gd name="connsiteY1" fmla="*/ 611094 h 676625"/>
              <a:gd name="connsiteX2" fmla="*/ 4170830 w 4170830"/>
              <a:gd name="connsiteY2" fmla="*/ 0 h 676625"/>
              <a:gd name="connsiteX0" fmla="*/ 0 w 4170830"/>
              <a:gd name="connsiteY0" fmla="*/ 582706 h 676625"/>
              <a:gd name="connsiteX1" fmla="*/ 3476065 w 4170830"/>
              <a:gd name="connsiteY1" fmla="*/ 611094 h 676625"/>
              <a:gd name="connsiteX2" fmla="*/ 4170830 w 4170830"/>
              <a:gd name="connsiteY2" fmla="*/ 0 h 676625"/>
              <a:gd name="connsiteX0" fmla="*/ 0 w 4170830"/>
              <a:gd name="connsiteY0" fmla="*/ 582706 h 652137"/>
              <a:gd name="connsiteX1" fmla="*/ 3450665 w 4170830"/>
              <a:gd name="connsiteY1" fmla="*/ 560294 h 652137"/>
              <a:gd name="connsiteX2" fmla="*/ 4170830 w 4170830"/>
              <a:gd name="connsiteY2" fmla="*/ 0 h 652137"/>
              <a:gd name="connsiteX0" fmla="*/ 0 w 4170830"/>
              <a:gd name="connsiteY0" fmla="*/ 582706 h 684159"/>
              <a:gd name="connsiteX1" fmla="*/ 3476065 w 4170830"/>
              <a:gd name="connsiteY1" fmla="*/ 623794 h 684159"/>
              <a:gd name="connsiteX2" fmla="*/ 4170830 w 4170830"/>
              <a:gd name="connsiteY2" fmla="*/ 0 h 684159"/>
              <a:gd name="connsiteX0" fmla="*/ 0 w 4170830"/>
              <a:gd name="connsiteY0" fmla="*/ 582706 h 709804"/>
              <a:gd name="connsiteX1" fmla="*/ 3526865 w 4170830"/>
              <a:gd name="connsiteY1" fmla="*/ 661894 h 709804"/>
              <a:gd name="connsiteX2" fmla="*/ 4170830 w 4170830"/>
              <a:gd name="connsiteY2" fmla="*/ 0 h 709804"/>
              <a:gd name="connsiteX0" fmla="*/ 0 w 4170830"/>
              <a:gd name="connsiteY0" fmla="*/ 582706 h 732369"/>
              <a:gd name="connsiteX1" fmla="*/ 3526865 w 4170830"/>
              <a:gd name="connsiteY1" fmla="*/ 661894 h 732369"/>
              <a:gd name="connsiteX2" fmla="*/ 4170830 w 4170830"/>
              <a:gd name="connsiteY2" fmla="*/ 0 h 732369"/>
              <a:gd name="connsiteX0" fmla="*/ 0 w 4170830"/>
              <a:gd name="connsiteY0" fmla="*/ 582706 h 749297"/>
              <a:gd name="connsiteX1" fmla="*/ 3526865 w 4170830"/>
              <a:gd name="connsiteY1" fmla="*/ 661894 h 749297"/>
              <a:gd name="connsiteX2" fmla="*/ 4170830 w 4170830"/>
              <a:gd name="connsiteY2" fmla="*/ 0 h 749297"/>
              <a:gd name="connsiteX0" fmla="*/ 0 w 4158130"/>
              <a:gd name="connsiteY0" fmla="*/ 671606 h 751491"/>
              <a:gd name="connsiteX1" fmla="*/ 3514165 w 4158130"/>
              <a:gd name="connsiteY1" fmla="*/ 661894 h 751491"/>
              <a:gd name="connsiteX2" fmla="*/ 4158130 w 4158130"/>
              <a:gd name="connsiteY2" fmla="*/ 0 h 751491"/>
              <a:gd name="connsiteX0" fmla="*/ 0 w 4196230"/>
              <a:gd name="connsiteY0" fmla="*/ 862106 h 953755"/>
              <a:gd name="connsiteX1" fmla="*/ 3514165 w 4196230"/>
              <a:gd name="connsiteY1" fmla="*/ 852394 h 953755"/>
              <a:gd name="connsiteX2" fmla="*/ 4196230 w 4196230"/>
              <a:gd name="connsiteY2" fmla="*/ 0 h 953755"/>
              <a:gd name="connsiteX0" fmla="*/ 0 w 4196230"/>
              <a:gd name="connsiteY0" fmla="*/ 862106 h 953755"/>
              <a:gd name="connsiteX1" fmla="*/ 3514165 w 4196230"/>
              <a:gd name="connsiteY1" fmla="*/ 852394 h 953755"/>
              <a:gd name="connsiteX2" fmla="*/ 3721847 w 4196230"/>
              <a:gd name="connsiteY2" fmla="*/ 781424 h 953755"/>
              <a:gd name="connsiteX3" fmla="*/ 4196230 w 4196230"/>
              <a:gd name="connsiteY3" fmla="*/ 0 h 953755"/>
              <a:gd name="connsiteX0" fmla="*/ 0 w 4196230"/>
              <a:gd name="connsiteY0" fmla="*/ 862106 h 917028"/>
              <a:gd name="connsiteX1" fmla="*/ 3514165 w 4196230"/>
              <a:gd name="connsiteY1" fmla="*/ 852394 h 917028"/>
              <a:gd name="connsiteX2" fmla="*/ 3823447 w 4196230"/>
              <a:gd name="connsiteY2" fmla="*/ 679824 h 917028"/>
              <a:gd name="connsiteX3" fmla="*/ 4196230 w 4196230"/>
              <a:gd name="connsiteY3" fmla="*/ 0 h 917028"/>
              <a:gd name="connsiteX0" fmla="*/ 0 w 4196230"/>
              <a:gd name="connsiteY0" fmla="*/ 862106 h 917028"/>
              <a:gd name="connsiteX1" fmla="*/ 3514165 w 4196230"/>
              <a:gd name="connsiteY1" fmla="*/ 852394 h 917028"/>
              <a:gd name="connsiteX2" fmla="*/ 3823447 w 4196230"/>
              <a:gd name="connsiteY2" fmla="*/ 679824 h 917028"/>
              <a:gd name="connsiteX3" fmla="*/ 4196230 w 4196230"/>
              <a:gd name="connsiteY3" fmla="*/ 0 h 917028"/>
              <a:gd name="connsiteX0" fmla="*/ 0 w 4196230"/>
              <a:gd name="connsiteY0" fmla="*/ 862106 h 917028"/>
              <a:gd name="connsiteX1" fmla="*/ 3145865 w 4196230"/>
              <a:gd name="connsiteY1" fmla="*/ 852394 h 917028"/>
              <a:gd name="connsiteX2" fmla="*/ 3823447 w 4196230"/>
              <a:gd name="connsiteY2" fmla="*/ 679824 h 917028"/>
              <a:gd name="connsiteX3" fmla="*/ 4196230 w 4196230"/>
              <a:gd name="connsiteY3" fmla="*/ 0 h 917028"/>
              <a:gd name="connsiteX0" fmla="*/ 0 w 4196230"/>
              <a:gd name="connsiteY0" fmla="*/ 862106 h 930711"/>
              <a:gd name="connsiteX1" fmla="*/ 3120465 w 4196230"/>
              <a:gd name="connsiteY1" fmla="*/ 890494 h 930711"/>
              <a:gd name="connsiteX2" fmla="*/ 3823447 w 4196230"/>
              <a:gd name="connsiteY2" fmla="*/ 679824 h 930711"/>
              <a:gd name="connsiteX3" fmla="*/ 4196230 w 4196230"/>
              <a:gd name="connsiteY3" fmla="*/ 0 h 930711"/>
              <a:gd name="connsiteX0" fmla="*/ 0 w 4196230"/>
              <a:gd name="connsiteY0" fmla="*/ 862106 h 936676"/>
              <a:gd name="connsiteX1" fmla="*/ 3120465 w 4196230"/>
              <a:gd name="connsiteY1" fmla="*/ 890494 h 936676"/>
              <a:gd name="connsiteX2" fmla="*/ 3861547 w 4196230"/>
              <a:gd name="connsiteY2" fmla="*/ 578224 h 936676"/>
              <a:gd name="connsiteX3" fmla="*/ 4196230 w 4196230"/>
              <a:gd name="connsiteY3" fmla="*/ 0 h 936676"/>
              <a:gd name="connsiteX0" fmla="*/ 0 w 4196230"/>
              <a:gd name="connsiteY0" fmla="*/ 862106 h 936676"/>
              <a:gd name="connsiteX1" fmla="*/ 3120465 w 4196230"/>
              <a:gd name="connsiteY1" fmla="*/ 890494 h 936676"/>
              <a:gd name="connsiteX2" fmla="*/ 3861547 w 4196230"/>
              <a:gd name="connsiteY2" fmla="*/ 578224 h 936676"/>
              <a:gd name="connsiteX3" fmla="*/ 4196230 w 4196230"/>
              <a:gd name="connsiteY3" fmla="*/ 0 h 936676"/>
              <a:gd name="connsiteX0" fmla="*/ 0 w 4196230"/>
              <a:gd name="connsiteY0" fmla="*/ 862106 h 936676"/>
              <a:gd name="connsiteX1" fmla="*/ 3120465 w 4196230"/>
              <a:gd name="connsiteY1" fmla="*/ 890494 h 936676"/>
              <a:gd name="connsiteX2" fmla="*/ 3861547 w 4196230"/>
              <a:gd name="connsiteY2" fmla="*/ 578224 h 936676"/>
              <a:gd name="connsiteX3" fmla="*/ 4196230 w 4196230"/>
              <a:gd name="connsiteY3" fmla="*/ 0 h 93667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196230" h="936676">
                <a:moveTo>
                  <a:pt x="0" y="862106"/>
                </a:moveTo>
                <a:cubicBezTo>
                  <a:pt x="1247588" y="975659"/>
                  <a:pt x="2476874" y="937808"/>
                  <a:pt x="3120465" y="890494"/>
                </a:cubicBezTo>
                <a:cubicBezTo>
                  <a:pt x="3764056" y="843180"/>
                  <a:pt x="3709770" y="859990"/>
                  <a:pt x="3861547" y="578224"/>
                </a:cubicBezTo>
                <a:cubicBezTo>
                  <a:pt x="3975224" y="436158"/>
                  <a:pt x="4117166" y="130237"/>
                  <a:pt x="4196230" y="0"/>
                </a:cubicBezTo>
              </a:path>
            </a:pathLst>
          </a:custGeom>
          <a:noFill/>
          <a:ln w="28575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TW" altLang="en-US" sz="800"/>
          </a:p>
        </p:txBody>
      </p:sp>
      <p:cxnSp>
        <p:nvCxnSpPr>
          <p:cNvPr id="8" name="直線接點 7">
            <a:extLst>
              <a:ext uri="{FF2B5EF4-FFF2-40B4-BE49-F238E27FC236}">
                <a16:creationId xmlns:a16="http://schemas.microsoft.com/office/drawing/2014/main" id="{997490BD-F142-BE4B-8547-BA17E8C497A8}"/>
              </a:ext>
            </a:extLst>
          </p:cNvPr>
          <p:cNvCxnSpPr/>
          <p:nvPr/>
        </p:nvCxnSpPr>
        <p:spPr>
          <a:xfrm>
            <a:off x="2099444" y="3618471"/>
            <a:ext cx="257107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接點 9">
            <a:extLst>
              <a:ext uri="{FF2B5EF4-FFF2-40B4-BE49-F238E27FC236}">
                <a16:creationId xmlns:a16="http://schemas.microsoft.com/office/drawing/2014/main" id="{7ECAD350-5039-C54F-AA41-CB3EA3D96443}"/>
              </a:ext>
            </a:extLst>
          </p:cNvPr>
          <p:cNvCxnSpPr/>
          <p:nvPr/>
        </p:nvCxnSpPr>
        <p:spPr>
          <a:xfrm flipV="1">
            <a:off x="2099444" y="2524655"/>
            <a:ext cx="0" cy="11049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F305EBF6-A06F-504B-A2C7-1AA834A22892}"/>
              </a:ext>
            </a:extLst>
          </p:cNvPr>
          <p:cNvSpPr txBox="1"/>
          <p:nvPr/>
        </p:nvSpPr>
        <p:spPr>
          <a:xfrm>
            <a:off x="2878252" y="3741288"/>
            <a:ext cx="100059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b="1" dirty="0"/>
              <a:t>Time after cut (</a:t>
            </a:r>
            <a:r>
              <a:rPr kumimoji="1" lang="en-US" altLang="zh-TW" sz="800" b="1" dirty="0" err="1"/>
              <a:t>hrs</a:t>
            </a:r>
            <a:r>
              <a:rPr kumimoji="1" lang="en-US" altLang="zh-TW" sz="800" b="1" dirty="0"/>
              <a:t>)</a:t>
            </a:r>
            <a:endParaRPr kumimoji="1" lang="zh-TW" altLang="en-US" sz="800" b="1" dirty="0"/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8BFDBFF9-8605-B648-BC05-79E92A25CD01}"/>
              </a:ext>
            </a:extLst>
          </p:cNvPr>
          <p:cNvSpPr txBox="1"/>
          <p:nvPr/>
        </p:nvSpPr>
        <p:spPr>
          <a:xfrm>
            <a:off x="1974248" y="361329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dirty="0"/>
              <a:t>0</a:t>
            </a:r>
            <a:endParaRPr kumimoji="1" lang="zh-TW" altLang="en-US" sz="800" dirty="0"/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45961964-FB2C-724D-9B53-334E83511E6B}"/>
              </a:ext>
            </a:extLst>
          </p:cNvPr>
          <p:cNvSpPr txBox="1"/>
          <p:nvPr/>
        </p:nvSpPr>
        <p:spPr>
          <a:xfrm>
            <a:off x="3473967" y="360783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dirty="0"/>
              <a:t>24</a:t>
            </a:r>
            <a:endParaRPr kumimoji="1" lang="zh-TW" altLang="en-US" sz="800" dirty="0"/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1FBC1993-4EFA-2846-BE1E-A4FD8AF14165}"/>
              </a:ext>
            </a:extLst>
          </p:cNvPr>
          <p:cNvSpPr txBox="1"/>
          <p:nvPr/>
        </p:nvSpPr>
        <p:spPr>
          <a:xfrm>
            <a:off x="4521348" y="361329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dirty="0"/>
              <a:t>44</a:t>
            </a:r>
            <a:endParaRPr kumimoji="1" lang="zh-TW" altLang="en-US" sz="800" dirty="0"/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F4C34AC4-4BD5-7247-A34E-EAE441734979}"/>
              </a:ext>
            </a:extLst>
          </p:cNvPr>
          <p:cNvSpPr txBox="1"/>
          <p:nvPr/>
        </p:nvSpPr>
        <p:spPr>
          <a:xfrm>
            <a:off x="2661025" y="2491441"/>
            <a:ext cx="162095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b="1" dirty="0"/>
              <a:t>Relative level in regenerative cells</a:t>
            </a:r>
            <a:endParaRPr kumimoji="1" lang="zh-TW" altLang="en-US" sz="800" b="1" dirty="0"/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801E79C0-F702-BB4A-83EC-4463794926E7}"/>
              </a:ext>
            </a:extLst>
          </p:cNvPr>
          <p:cNvSpPr txBox="1"/>
          <p:nvPr/>
        </p:nvSpPr>
        <p:spPr>
          <a:xfrm>
            <a:off x="2099442" y="2708122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uxin</a:t>
            </a:r>
            <a:endParaRPr kumimoji="1" lang="zh-TW" altLang="en-US" sz="800" dirty="0">
              <a:solidFill>
                <a:schemeClr val="accent6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38FB2E3D-295C-FE4E-BC47-BCFE19E2FDD9}"/>
              </a:ext>
            </a:extLst>
          </p:cNvPr>
          <p:cNvSpPr txBox="1"/>
          <p:nvPr/>
        </p:nvSpPr>
        <p:spPr>
          <a:xfrm>
            <a:off x="2116306" y="3299257"/>
            <a:ext cx="5517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pPINA</a:t>
            </a:r>
            <a:endParaRPr kumimoji="1" lang="zh-TW" altLang="en-US" sz="80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8AD61BFE-678B-1141-9917-4498E93BAF9D}"/>
              </a:ext>
            </a:extLst>
          </p:cNvPr>
          <p:cNvSpPr txBox="1"/>
          <p:nvPr/>
        </p:nvSpPr>
        <p:spPr>
          <a:xfrm>
            <a:off x="4138353" y="361452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dirty="0"/>
              <a:t>36</a:t>
            </a:r>
            <a:endParaRPr kumimoji="1" lang="zh-TW" altLang="en-US" sz="800" dirty="0"/>
          </a:p>
        </p:txBody>
      </p:sp>
      <p:sp>
        <p:nvSpPr>
          <p:cNvPr id="22" name="文字方塊 21">
            <a:extLst>
              <a:ext uri="{FF2B5EF4-FFF2-40B4-BE49-F238E27FC236}">
                <a16:creationId xmlns:a16="http://schemas.microsoft.com/office/drawing/2014/main" id="{9DECF103-ED1F-3F40-916F-D6B75CB174E7}"/>
              </a:ext>
            </a:extLst>
          </p:cNvPr>
          <p:cNvSpPr txBox="1"/>
          <p:nvPr/>
        </p:nvSpPr>
        <p:spPr>
          <a:xfrm>
            <a:off x="3806160" y="360216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dirty="0"/>
              <a:t>32</a:t>
            </a:r>
            <a:endParaRPr kumimoji="1" lang="zh-TW" altLang="en-US" sz="800" dirty="0"/>
          </a:p>
        </p:txBody>
      </p:sp>
      <p:cxnSp>
        <p:nvCxnSpPr>
          <p:cNvPr id="24" name="直線接點 23">
            <a:extLst>
              <a:ext uri="{FF2B5EF4-FFF2-40B4-BE49-F238E27FC236}">
                <a16:creationId xmlns:a16="http://schemas.microsoft.com/office/drawing/2014/main" id="{3939BA99-3F50-764D-9101-E90193A698A4}"/>
              </a:ext>
            </a:extLst>
          </p:cNvPr>
          <p:cNvCxnSpPr>
            <a:stCxn id="14" idx="0"/>
          </p:cNvCxnSpPr>
          <p:nvPr/>
        </p:nvCxnSpPr>
        <p:spPr>
          <a:xfrm flipV="1">
            <a:off x="3617596" y="3257458"/>
            <a:ext cx="0" cy="350374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文字方塊 24">
            <a:extLst>
              <a:ext uri="{FF2B5EF4-FFF2-40B4-BE49-F238E27FC236}">
                <a16:creationId xmlns:a16="http://schemas.microsoft.com/office/drawing/2014/main" id="{FDB20F15-3304-EE47-9F68-771B8B29EE47}"/>
              </a:ext>
            </a:extLst>
          </p:cNvPr>
          <p:cNvSpPr txBox="1"/>
          <p:nvPr/>
        </p:nvSpPr>
        <p:spPr>
          <a:xfrm>
            <a:off x="3416861" y="3077105"/>
            <a:ext cx="4603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auxin </a:t>
            </a:r>
            <a:endParaRPr kumimoji="1"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箭頭接點 26">
            <a:extLst>
              <a:ext uri="{FF2B5EF4-FFF2-40B4-BE49-F238E27FC236}">
                <a16:creationId xmlns:a16="http://schemas.microsoft.com/office/drawing/2014/main" id="{874D4A24-BEDB-5246-B635-BB24E1EF9DB7}"/>
              </a:ext>
            </a:extLst>
          </p:cNvPr>
          <p:cNvCxnSpPr>
            <a:cxnSpLocks/>
          </p:cNvCxnSpPr>
          <p:nvPr/>
        </p:nvCxnSpPr>
        <p:spPr>
          <a:xfrm flipV="1">
            <a:off x="3806160" y="3104065"/>
            <a:ext cx="0" cy="144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文字方塊 27">
            <a:extLst>
              <a:ext uri="{FF2B5EF4-FFF2-40B4-BE49-F238E27FC236}">
                <a16:creationId xmlns:a16="http://schemas.microsoft.com/office/drawing/2014/main" id="{4D2C82A2-0E1F-D142-B13A-6079A6F09F01}"/>
              </a:ext>
            </a:extLst>
          </p:cNvPr>
          <p:cNvSpPr txBox="1"/>
          <p:nvPr/>
        </p:nvSpPr>
        <p:spPr>
          <a:xfrm>
            <a:off x="3949789" y="2829512"/>
            <a:ext cx="5806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dirty="0" err="1">
                <a:latin typeface="Arial" panose="020B0604020202020204" pitchFamily="34" charset="0"/>
                <a:cs typeface="Arial" panose="020B0604020202020204" pitchFamily="34" charset="0"/>
              </a:rPr>
              <a:t>PpPINA</a:t>
            </a:r>
            <a:r>
              <a:rPr kumimoji="1" lang="en-US" altLang="zh-TW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kumimoji="1" lang="zh-TW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線箭頭接點 28">
            <a:extLst>
              <a:ext uri="{FF2B5EF4-FFF2-40B4-BE49-F238E27FC236}">
                <a16:creationId xmlns:a16="http://schemas.microsoft.com/office/drawing/2014/main" id="{8D054C86-E1EA-5E46-BBF1-EC289A9B2084}"/>
              </a:ext>
            </a:extLst>
          </p:cNvPr>
          <p:cNvCxnSpPr/>
          <p:nvPr/>
        </p:nvCxnSpPr>
        <p:spPr>
          <a:xfrm flipV="1">
            <a:off x="4459779" y="2855688"/>
            <a:ext cx="0" cy="144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接點 29">
            <a:extLst>
              <a:ext uri="{FF2B5EF4-FFF2-40B4-BE49-F238E27FC236}">
                <a16:creationId xmlns:a16="http://schemas.microsoft.com/office/drawing/2014/main" id="{14A97A68-6AF6-5849-BC38-FDD5532DF387}"/>
              </a:ext>
            </a:extLst>
          </p:cNvPr>
          <p:cNvCxnSpPr>
            <a:cxnSpLocks/>
          </p:cNvCxnSpPr>
          <p:nvPr/>
        </p:nvCxnSpPr>
        <p:spPr>
          <a:xfrm flipV="1">
            <a:off x="4286463" y="3044796"/>
            <a:ext cx="0" cy="57600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矩形 35">
            <a:extLst>
              <a:ext uri="{FF2B5EF4-FFF2-40B4-BE49-F238E27FC236}">
                <a16:creationId xmlns:a16="http://schemas.microsoft.com/office/drawing/2014/main" id="{10EE296E-A525-5A44-95DC-83A5AF8ED64C}"/>
              </a:ext>
            </a:extLst>
          </p:cNvPr>
          <p:cNvSpPr/>
          <p:nvPr/>
        </p:nvSpPr>
        <p:spPr>
          <a:xfrm>
            <a:off x="655598" y="1564837"/>
            <a:ext cx="573091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TW" sz="1200" b="1" dirty="0">
                <a:solidFill>
                  <a:prstClr val="black"/>
                </a:solidFill>
                <a:cs typeface="+mj-cs"/>
              </a:rPr>
              <a:t>Figure S5. Illustration of auxin and </a:t>
            </a:r>
            <a:r>
              <a:rPr lang="en-US" altLang="zh-TW" sz="1200" b="1" dirty="0" err="1">
                <a:solidFill>
                  <a:prstClr val="black"/>
                </a:solidFill>
                <a:cs typeface="+mj-cs"/>
              </a:rPr>
              <a:t>PpPINA</a:t>
            </a:r>
            <a:r>
              <a:rPr lang="en-US" altLang="zh-TW" sz="1200" b="1" dirty="0">
                <a:solidFill>
                  <a:prstClr val="black"/>
                </a:solidFill>
                <a:cs typeface="+mj-cs"/>
              </a:rPr>
              <a:t> levels during moss leaf cell reprogramming.</a:t>
            </a:r>
            <a:endParaRPr lang="zh-TW" altLang="en-US" sz="1200" b="1" dirty="0">
              <a:solidFill>
                <a:prstClr val="black"/>
              </a:solidFill>
              <a:cs typeface="+mj-cs"/>
            </a:endParaRPr>
          </a:p>
        </p:txBody>
      </p:sp>
      <p:sp>
        <p:nvSpPr>
          <p:cNvPr id="37" name="文字方塊 36">
            <a:extLst>
              <a:ext uri="{FF2B5EF4-FFF2-40B4-BE49-F238E27FC236}">
                <a16:creationId xmlns:a16="http://schemas.microsoft.com/office/drawing/2014/main" id="{85D8499D-1ED0-9142-A869-8EA8AD8064D9}"/>
              </a:ext>
            </a:extLst>
          </p:cNvPr>
          <p:cNvSpPr txBox="1"/>
          <p:nvPr/>
        </p:nvSpPr>
        <p:spPr>
          <a:xfrm>
            <a:off x="4607646" y="2891966"/>
            <a:ext cx="72487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800" b="1" dirty="0"/>
              <a:t>Cell outgrow</a:t>
            </a:r>
            <a:endParaRPr kumimoji="1" lang="zh-TW" altLang="en-US" sz="800" b="1" dirty="0"/>
          </a:p>
        </p:txBody>
      </p:sp>
      <p:sp>
        <p:nvSpPr>
          <p:cNvPr id="3" name="矩形 2">
            <a:extLst>
              <a:ext uri="{FF2B5EF4-FFF2-40B4-BE49-F238E27FC236}">
                <a16:creationId xmlns:a16="http://schemas.microsoft.com/office/drawing/2014/main" id="{23666F5C-1A72-0A41-BB39-3264E5A65E46}"/>
              </a:ext>
            </a:extLst>
          </p:cNvPr>
          <p:cNvSpPr/>
          <p:nvPr/>
        </p:nvSpPr>
        <p:spPr>
          <a:xfrm>
            <a:off x="1757003" y="4268809"/>
            <a:ext cx="3429000" cy="168046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. Illustration of auxin and </a:t>
            </a:r>
            <a:r>
              <a:rPr lang="en-US" altLang="zh-TW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PINA</a:t>
            </a:r>
            <a:r>
              <a:rPr lang="en-US" altLang="zh-TW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evels during moss leaf cell reprogramming.</a:t>
            </a:r>
            <a:endParaRPr lang="zh-TW" altLang="zh-TW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levels of subcellular auxin and </a:t>
            </a:r>
            <a:r>
              <a:rPr lang="en-US" altLang="zh-TW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PINA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regenerative cells are illustrated based on the time-lapse imaging analysis of R2D2 and </a:t>
            </a:r>
            <a:r>
              <a:rPr lang="en-US" altLang="zh-TW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PINA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FP during cell reprogramming. The time point of auxin and </a:t>
            </a:r>
            <a:r>
              <a:rPr lang="en-US" altLang="zh-TW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pPINA</a:t>
            </a:r>
            <a:r>
              <a:rPr lang="en-US" altLang="zh-TW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cumulation and cell outgrow are indicated. </a:t>
            </a:r>
            <a:endParaRPr lang="zh-TW" altLang="zh-TW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0865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09</TotalTime>
  <Words>453</Words>
  <Application>Microsoft Macintosh PowerPoint</Application>
  <PresentationFormat>A4 紙張 (210x297 公釐)</PresentationFormat>
  <Paragraphs>53</Paragraphs>
  <Slides>5</Slides>
  <Notes>2</Notes>
  <HiddenSlides>0</HiddenSlides>
  <MMClips>0</MMClips>
  <ScaleCrop>false</ScaleCrop>
  <HeadingPairs>
    <vt:vector size="8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佈景主題</vt:lpstr>
      <vt:lpstr>Prism 8</vt:lpstr>
      <vt:lpstr>PowerPoint 簡報</vt:lpstr>
      <vt:lpstr>Figure S2. Phosphomutations on PpPINA and wildtype KfPIN are capable of exporting auxin when overexpressing in P. patens. </vt:lpstr>
      <vt:lpstr>Figure S3. Overexpressed PpPINA-GFPAA is polarized before visible cell outgrow. </vt:lpstr>
      <vt:lpstr>PowerPoint 簡報</vt:lpstr>
      <vt:lpstr>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Han Tang</dc:creator>
  <cp:lastModifiedBy>Han Tang</cp:lastModifiedBy>
  <cp:revision>62</cp:revision>
  <cp:lastPrinted>2024-12-10T04:09:49Z</cp:lastPrinted>
  <dcterms:created xsi:type="dcterms:W3CDTF">2024-05-28T08:23:24Z</dcterms:created>
  <dcterms:modified xsi:type="dcterms:W3CDTF">2024-12-11T10:11:32Z</dcterms:modified>
</cp:coreProperties>
</file>